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9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429539" y="1063571"/>
            <a:ext cx="4027498" cy="162668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l Table S5: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Summary of TMB ranges per cohort and MSI (TMB10+ only). The median and interquartile range of TMB is shown per group within the cohorts, grouped by MSI status.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CF981919-E5F3-AB4E-B3AC-275B4DDB608A}"/>
              </a:ext>
            </a:extLst>
          </p:cNvPr>
          <p:cNvGraphicFramePr>
            <a:graphicFrameLocks noGrp="1"/>
          </p:cNvGraphicFramePr>
          <p:nvPr/>
        </p:nvGraphicFramePr>
        <p:xfrm>
          <a:off x="6928019" y="658255"/>
          <a:ext cx="4445000" cy="20320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550360">
                  <a:extLst>
                    <a:ext uri="{9D8B030D-6E8A-4147-A177-3AD203B41FA5}">
                      <a16:colId xmlns:a16="http://schemas.microsoft.com/office/drawing/2014/main" val="4041581847"/>
                    </a:ext>
                  </a:extLst>
                </a:gridCol>
                <a:gridCol w="1131858">
                  <a:extLst>
                    <a:ext uri="{9D8B030D-6E8A-4147-A177-3AD203B41FA5}">
                      <a16:colId xmlns:a16="http://schemas.microsoft.com/office/drawing/2014/main" val="4017892362"/>
                    </a:ext>
                  </a:extLst>
                </a:gridCol>
                <a:gridCol w="418502">
                  <a:extLst>
                    <a:ext uri="{9D8B030D-6E8A-4147-A177-3AD203B41FA5}">
                      <a16:colId xmlns:a16="http://schemas.microsoft.com/office/drawing/2014/main" val="2557850190"/>
                    </a:ext>
                  </a:extLst>
                </a:gridCol>
                <a:gridCol w="1344280">
                  <a:extLst>
                    <a:ext uri="{9D8B030D-6E8A-4147-A177-3AD203B41FA5}">
                      <a16:colId xmlns:a16="http://schemas.microsoft.com/office/drawing/2014/main" val="2997719067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Coho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TMB (IQR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5207901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1L (TMB10+ only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 unknow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3 (11.3 - 22.2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4167125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1L (TMB10+ only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-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6 (29.4 - 48.4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648968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L (TMB10+ only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MS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2.5 (10 - 13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387675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 (TMB10+ only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MSI unknow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4.8 (15.2 - 41.3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961838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 (TMB10+ only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-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4.9 (26.1 - 43.4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987849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 (TMB10+ only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.3 (10 - 12.5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5266834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 (TMB10+ only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 unknow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.3 (11.3 - 11.3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0969062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 (TMB10+ only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I-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4.9 (27.8 - 38.2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902438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 (TMB10+ only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MS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2.5 (12.5 - 12.5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87377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83552017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74</Words>
  <Application>Microsoft Macintosh PowerPoint</Application>
  <PresentationFormat>Widescreen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8</cp:revision>
  <dcterms:created xsi:type="dcterms:W3CDTF">2022-06-12T16:24:02Z</dcterms:created>
  <dcterms:modified xsi:type="dcterms:W3CDTF">2022-06-27T20:36:58Z</dcterms:modified>
</cp:coreProperties>
</file>